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4" r:id="rId3"/>
    <p:sldId id="259" r:id="rId4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5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1771" y="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62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105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722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55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94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6059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6701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236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9320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906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981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B4BB8-7174-4C6E-B357-D4001D4C367D}" type="datetimeFigureOut">
              <a:rPr kumimoji="1" lang="ja-JP" altLang="en-US" smtClean="0"/>
              <a:t>2026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A61AB-2525-4601-91CB-4EE198508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48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4F1E681-2AA9-55FD-904D-45EF7BE45E52}"/>
              </a:ext>
            </a:extLst>
          </p:cNvPr>
          <p:cNvSpPr txBox="1"/>
          <p:nvPr/>
        </p:nvSpPr>
        <p:spPr>
          <a:xfrm>
            <a:off x="1907701" y="386518"/>
            <a:ext cx="304259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Primer sequences for real-time PC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5A49764C-130E-36D2-5212-EEB7946C9E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5416459"/>
              </p:ext>
            </p:extLst>
          </p:nvPr>
        </p:nvGraphicFramePr>
        <p:xfrm>
          <a:off x="526079" y="759410"/>
          <a:ext cx="5915024" cy="2490660"/>
        </p:xfrm>
        <a:graphic>
          <a:graphicData uri="http://schemas.openxmlformats.org/drawingml/2006/table">
            <a:tbl>
              <a:tblPr/>
              <a:tblGrid>
                <a:gridCol w="1023076">
                  <a:extLst>
                    <a:ext uri="{9D8B030D-6E8A-4147-A177-3AD203B41FA5}">
                      <a16:colId xmlns:a16="http://schemas.microsoft.com/office/drawing/2014/main" val="540395190"/>
                    </a:ext>
                  </a:extLst>
                </a:gridCol>
                <a:gridCol w="2445974">
                  <a:extLst>
                    <a:ext uri="{9D8B030D-6E8A-4147-A177-3AD203B41FA5}">
                      <a16:colId xmlns:a16="http://schemas.microsoft.com/office/drawing/2014/main" val="1264973953"/>
                    </a:ext>
                  </a:extLst>
                </a:gridCol>
                <a:gridCol w="2445974">
                  <a:extLst>
                    <a:ext uri="{9D8B030D-6E8A-4147-A177-3AD203B41FA5}">
                      <a16:colId xmlns:a16="http://schemas.microsoft.com/office/drawing/2014/main" val="2428050737"/>
                    </a:ext>
                  </a:extLst>
                </a:gridCol>
              </a:tblGrid>
              <a:tr h="207555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ene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' Primer (5'-3')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' Primer (5'-3')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0127411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D90.2 (Thy1.2)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CCAGAATCCAAGTCGGAA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TTATTCTCATGGCGGCAGT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9199183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D49f (Itga6)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GAGTCGCGGGATATCTTT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GGGCTCCAAAAACAATGTA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8689947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Oct4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GCTGAAGCAGAAGAGGATCACCTTG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GTTCTTAAGGCTGAGCTGCAAGG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2656303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fra1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CAAGAACAAGCCTCTAGGGCCA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TGGATTTCAGCTTCTGTGCCTG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7980943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nmt1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CAAGCTCCGGACCCTGGATGTGT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GAGGCCGGTAGTAGTCACAGTAG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184049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nmt3a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CACCTATGGGCTGCTGCGAAGACG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TGCCTCCAATCACCAGGTCGAATG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9154069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nmt3b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CGAAGGAGGAAGCTTAGGG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AACGATGTGCTTCTGGTC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9747213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et1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GAAAGAACAGCCACCAGAT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TGCTCTTCTTCCCCATGA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8934027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et2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GTTGTTGTCAGGGTGAGAAT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CTTGCTTCTGGCAAACTTACA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7684644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et3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CCGGATTGAGAAGGTCAT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CAGGCCAGGATCAAGATAA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6055281"/>
                  </a:ext>
                </a:extLst>
              </a:tr>
              <a:tr h="20755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pb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ACTGTTCCAAAAACAGTGGA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ATGCTCTTTCCTCCTGTGC</a:t>
                      </a:r>
                    </a:p>
                  </a:txBody>
                  <a:tcPr marL="4410" marR="4410" marT="44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84754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71867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D0DA451-C3C9-AC96-FE27-47EDDB86BAD7}"/>
              </a:ext>
            </a:extLst>
          </p:cNvPr>
          <p:cNvSpPr txBox="1"/>
          <p:nvPr/>
        </p:nvSpPr>
        <p:spPr>
          <a:xfrm>
            <a:off x="5935949" y="8693841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1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D2937D3-8DB9-A1CC-6795-3D8764CCC52A}"/>
              </a:ext>
            </a:extLst>
          </p:cNvPr>
          <p:cNvSpPr txBox="1"/>
          <p:nvPr/>
        </p:nvSpPr>
        <p:spPr>
          <a:xfrm>
            <a:off x="191705" y="1042675"/>
            <a:ext cx="227297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/>
              <a:t>(A) Control</a:t>
            </a:r>
            <a:r>
              <a:rPr lang="ja-JP" altLang="en-US" sz="1100" dirty="0"/>
              <a:t>（</a:t>
            </a:r>
            <a:r>
              <a:rPr lang="en-US" altLang="ja-JP" sz="1100" dirty="0"/>
              <a:t>seminiferous tubules</a:t>
            </a:r>
            <a:r>
              <a:rPr lang="ja-JP" altLang="en-US" sz="1100" dirty="0"/>
              <a:t>）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F16ED08-FADF-58B4-8518-2412F262F353}"/>
              </a:ext>
            </a:extLst>
          </p:cNvPr>
          <p:cNvSpPr txBox="1"/>
          <p:nvPr/>
        </p:nvSpPr>
        <p:spPr>
          <a:xfrm>
            <a:off x="3333750" y="1042675"/>
            <a:ext cx="227297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/>
              <a:t>(B) Arsenic</a:t>
            </a:r>
            <a:r>
              <a:rPr lang="ja-JP" altLang="en-US" sz="1100" dirty="0"/>
              <a:t>（</a:t>
            </a:r>
            <a:r>
              <a:rPr lang="en-US" altLang="ja-JP" sz="1100" dirty="0"/>
              <a:t>seminiferous tubules</a:t>
            </a:r>
            <a:r>
              <a:rPr lang="ja-JP" altLang="en-US" sz="1100" dirty="0"/>
              <a:t>）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8FD96DD-F2BA-279B-02DB-B5718485DA14}"/>
              </a:ext>
            </a:extLst>
          </p:cNvPr>
          <p:cNvSpPr txBox="1"/>
          <p:nvPr/>
        </p:nvSpPr>
        <p:spPr>
          <a:xfrm>
            <a:off x="677119" y="3223287"/>
            <a:ext cx="5354997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100" dirty="0"/>
              <a:t>Fig. S1. Histological analysis of testes from F1 mice following gestational arsenic exposure.</a:t>
            </a:r>
          </a:p>
          <a:p>
            <a:pPr algn="just"/>
            <a:r>
              <a:rPr lang="en-US" altLang="ja-JP" sz="1100" dirty="0"/>
              <a:t>Representative histological images (Hematoxylin and eosin (H&amp;E) staining) of testes from F1 mice at 17 weeks of age following gestational arsenic exposure. (A) Control group; (B) arsenic-exposed group. </a:t>
            </a:r>
          </a:p>
          <a:p>
            <a:pPr algn="just"/>
            <a:r>
              <a:rPr lang="en-US" altLang="ja-JP" sz="1100" dirty="0"/>
              <a:t>No apparent histological abnormalities were observed in the seminiferous tubules of arsenic-exposed mice compared with controls.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9EC95EFA-3BED-D23F-9127-78A4595CDE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7580" y="1334453"/>
            <a:ext cx="3027045" cy="153019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FD06DA6-0D58-A09F-BAC6-7A619FD883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940" y="1334452"/>
            <a:ext cx="3027045" cy="153019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2410368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ダイアグラム&#10;&#10;中程度の精度で自動的に生成された説明">
            <a:extLst>
              <a:ext uri="{FF2B5EF4-FFF2-40B4-BE49-F238E27FC236}">
                <a16:creationId xmlns:a16="http://schemas.microsoft.com/office/drawing/2014/main" id="{E0CEF80F-AD7B-5EDA-6F86-D97796388D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3866" y="1253133"/>
            <a:ext cx="1645924" cy="1645924"/>
          </a:xfrm>
          <a:prstGeom prst="rect">
            <a:avLst/>
          </a:prstGeom>
        </p:spPr>
      </p:pic>
      <p:pic>
        <p:nvPicPr>
          <p:cNvPr id="3" name="図 2" descr="グラフ, ヒストグラム&#10;&#10;自動的に生成された説明">
            <a:extLst>
              <a:ext uri="{FF2B5EF4-FFF2-40B4-BE49-F238E27FC236}">
                <a16:creationId xmlns:a16="http://schemas.microsoft.com/office/drawing/2014/main" id="{2B38F22D-F98A-48C3-D5BE-1979979926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1739" y="1139372"/>
            <a:ext cx="2560325" cy="192024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02520A7-FA6E-77A0-2C5E-0A38572069AA}"/>
              </a:ext>
            </a:extLst>
          </p:cNvPr>
          <p:cNvSpPr txBox="1"/>
          <p:nvPr/>
        </p:nvSpPr>
        <p:spPr>
          <a:xfrm>
            <a:off x="667915" y="923091"/>
            <a:ext cx="1337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Prospermatogonia</a:t>
            </a:r>
            <a:endParaRPr kumimoji="1" lang="ja-JP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16BD64C-5FA3-913F-88FC-8F8DE49A2FD3}"/>
              </a:ext>
            </a:extLst>
          </p:cNvPr>
          <p:cNvSpPr txBox="1"/>
          <p:nvPr/>
        </p:nvSpPr>
        <p:spPr>
          <a:xfrm>
            <a:off x="667915" y="3104865"/>
            <a:ext cx="1579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ype A spermatogonia</a:t>
            </a:r>
            <a:endParaRPr kumimoji="1" lang="ja-JP" altLang="en-US" sz="1200" dirty="0"/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A04E674B-4E36-5894-6D71-10937EB6C066}"/>
              </a:ext>
            </a:extLst>
          </p:cNvPr>
          <p:cNvGrpSpPr/>
          <p:nvPr/>
        </p:nvGrpSpPr>
        <p:grpSpPr>
          <a:xfrm>
            <a:off x="1772837" y="3356381"/>
            <a:ext cx="1645924" cy="1769706"/>
            <a:chOff x="1530926" y="931957"/>
            <a:chExt cx="1645924" cy="1769706"/>
          </a:xfrm>
        </p:grpSpPr>
        <p:pic>
          <p:nvPicPr>
            <p:cNvPr id="25" name="図 24" descr="グラフ が含まれている画像&#10;&#10;自動的に生成された説明">
              <a:extLst>
                <a:ext uri="{FF2B5EF4-FFF2-40B4-BE49-F238E27FC236}">
                  <a16:creationId xmlns:a16="http://schemas.microsoft.com/office/drawing/2014/main" id="{04316E3A-3527-9969-894B-8E4B1AF90E2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0926" y="1055739"/>
              <a:ext cx="1645924" cy="1645924"/>
            </a:xfrm>
            <a:prstGeom prst="rect">
              <a:avLst/>
            </a:prstGeom>
          </p:spPr>
        </p:pic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DC97DE7E-5846-9A2D-DDDA-29224CD0599D}"/>
                </a:ext>
              </a:extLst>
            </p:cNvPr>
            <p:cNvGrpSpPr/>
            <p:nvPr/>
          </p:nvGrpSpPr>
          <p:grpSpPr>
            <a:xfrm>
              <a:off x="2288904" y="931957"/>
              <a:ext cx="387199" cy="246221"/>
              <a:chOff x="2288904" y="931957"/>
              <a:chExt cx="387199" cy="246221"/>
            </a:xfrm>
          </p:grpSpPr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1E937ACD-B20A-2665-FE30-684686E9C9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88904" y="1121955"/>
                <a:ext cx="3871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98594C44-2F03-0E6E-4500-322A145AB0BA}"/>
                  </a:ext>
                </a:extLst>
              </p:cNvPr>
              <p:cNvSpPr txBox="1"/>
              <p:nvPr/>
            </p:nvSpPr>
            <p:spPr>
              <a:xfrm>
                <a:off x="2319116" y="931957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/>
                  <a:t>**</a:t>
                </a:r>
                <a:endParaRPr kumimoji="1" lang="ja-JP" altLang="en-US" sz="1000" dirty="0"/>
              </a:p>
            </p:txBody>
          </p:sp>
        </p:grp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91BAB6B7-1E8F-687A-E0E7-590CE7406721}"/>
              </a:ext>
            </a:extLst>
          </p:cNvPr>
          <p:cNvGrpSpPr/>
          <p:nvPr/>
        </p:nvGrpSpPr>
        <p:grpSpPr>
          <a:xfrm>
            <a:off x="3746328" y="3239611"/>
            <a:ext cx="2560325" cy="1920244"/>
            <a:chOff x="912663" y="4873466"/>
            <a:chExt cx="2560325" cy="1920244"/>
          </a:xfrm>
        </p:grpSpPr>
        <p:pic>
          <p:nvPicPr>
            <p:cNvPr id="30" name="図 29" descr="グラフ, ダイアグラム&#10;&#10;自動的に生成された説明">
              <a:extLst>
                <a:ext uri="{FF2B5EF4-FFF2-40B4-BE49-F238E27FC236}">
                  <a16:creationId xmlns:a16="http://schemas.microsoft.com/office/drawing/2014/main" id="{E4717A67-CF9D-D51E-F03A-6FAAD7C883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2663" y="4873466"/>
              <a:ext cx="2560325" cy="1920244"/>
            </a:xfrm>
            <a:prstGeom prst="rect">
              <a:avLst/>
            </a:prstGeom>
          </p:spPr>
        </p:pic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3B1C5F37-5D1A-F115-277E-014302E19490}"/>
                </a:ext>
              </a:extLst>
            </p:cNvPr>
            <p:cNvGrpSpPr/>
            <p:nvPr/>
          </p:nvGrpSpPr>
          <p:grpSpPr>
            <a:xfrm>
              <a:off x="2876206" y="4920524"/>
              <a:ext cx="312906" cy="246221"/>
              <a:chOff x="2868186" y="4920524"/>
              <a:chExt cx="312906" cy="246221"/>
            </a:xfrm>
          </p:grpSpPr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id="{2B40CC98-2CA3-C47F-6E37-AC5715414B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64175" y="5081176"/>
                <a:ext cx="13008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0412F06C-7EE2-EDFC-CD5C-FB6C9A56F39E}"/>
                  </a:ext>
                </a:extLst>
              </p:cNvPr>
              <p:cNvSpPr txBox="1"/>
              <p:nvPr/>
            </p:nvSpPr>
            <p:spPr>
              <a:xfrm>
                <a:off x="2868186" y="4920524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/>
                  <a:t>**</a:t>
                </a:r>
                <a:endParaRPr kumimoji="1" lang="ja-JP" altLang="en-US" sz="1000" dirty="0"/>
              </a:p>
            </p:txBody>
          </p:sp>
        </p:grp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D0C24193-0C67-BF6C-3B2F-AD905B39B9EF}"/>
                </a:ext>
              </a:extLst>
            </p:cNvPr>
            <p:cNvGrpSpPr/>
            <p:nvPr/>
          </p:nvGrpSpPr>
          <p:grpSpPr>
            <a:xfrm>
              <a:off x="2704399" y="4920524"/>
              <a:ext cx="312906" cy="246221"/>
              <a:chOff x="2868186" y="4920524"/>
              <a:chExt cx="312906" cy="246221"/>
            </a:xfrm>
          </p:grpSpPr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BD5F6956-92D4-C049-2CF6-28CE26EAA5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64175" y="5081176"/>
                <a:ext cx="13008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F1F129E2-0764-CD0B-8EAC-F2F63573ED91}"/>
                  </a:ext>
                </a:extLst>
              </p:cNvPr>
              <p:cNvSpPr txBox="1"/>
              <p:nvPr/>
            </p:nvSpPr>
            <p:spPr>
              <a:xfrm>
                <a:off x="2868186" y="4920524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/>
                  <a:t>**</a:t>
                </a:r>
                <a:endParaRPr kumimoji="1" lang="ja-JP" altLang="en-US" sz="1000" dirty="0"/>
              </a:p>
            </p:txBody>
          </p:sp>
        </p:grpSp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92680FD8-9FDD-0E14-3C94-0DFD5F588FC6}"/>
                </a:ext>
              </a:extLst>
            </p:cNvPr>
            <p:cNvGrpSpPr/>
            <p:nvPr/>
          </p:nvGrpSpPr>
          <p:grpSpPr>
            <a:xfrm>
              <a:off x="2532592" y="4920524"/>
              <a:ext cx="312906" cy="246221"/>
              <a:chOff x="2868186" y="4920524"/>
              <a:chExt cx="312906" cy="246221"/>
            </a:xfrm>
          </p:grpSpPr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9251E987-4622-8448-D063-9239F35516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64175" y="5081176"/>
                <a:ext cx="13008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478DD3FE-9A4A-F037-A6EB-E6621CCA1404}"/>
                  </a:ext>
                </a:extLst>
              </p:cNvPr>
              <p:cNvSpPr txBox="1"/>
              <p:nvPr/>
            </p:nvSpPr>
            <p:spPr>
              <a:xfrm>
                <a:off x="2868186" y="4920524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/>
                  <a:t>**</a:t>
                </a:r>
                <a:endParaRPr kumimoji="1" lang="ja-JP" altLang="en-US" sz="1000" dirty="0"/>
              </a:p>
            </p:txBody>
          </p:sp>
        </p:grp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5FCAF3FA-6C4B-0260-5AAB-713773CF4D4E}"/>
              </a:ext>
            </a:extLst>
          </p:cNvPr>
          <p:cNvGrpSpPr/>
          <p:nvPr/>
        </p:nvGrpSpPr>
        <p:grpSpPr>
          <a:xfrm>
            <a:off x="782102" y="3843802"/>
            <a:ext cx="844550" cy="445274"/>
            <a:chOff x="3857397" y="6295996"/>
            <a:chExt cx="844550" cy="445274"/>
          </a:xfrm>
        </p:grpSpPr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D0DC814D-0A1F-622F-8E8B-89A743C54F40}"/>
                </a:ext>
              </a:extLst>
            </p:cNvPr>
            <p:cNvSpPr/>
            <p:nvPr/>
          </p:nvSpPr>
          <p:spPr>
            <a:xfrm>
              <a:off x="3933597" y="6563084"/>
              <a:ext cx="146050" cy="857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66B04A45-7405-6E5E-6822-8333599CD130}"/>
                </a:ext>
              </a:extLst>
            </p:cNvPr>
            <p:cNvSpPr/>
            <p:nvPr/>
          </p:nvSpPr>
          <p:spPr>
            <a:xfrm>
              <a:off x="3933597" y="6388459"/>
              <a:ext cx="146050" cy="8572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3C88DFD5-6932-6F41-5E7B-B2D1C149F8BA}"/>
                </a:ext>
              </a:extLst>
            </p:cNvPr>
            <p:cNvSpPr txBox="1"/>
            <p:nvPr/>
          </p:nvSpPr>
          <p:spPr>
            <a:xfrm>
              <a:off x="4031686" y="6302346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Control</a:t>
              </a:r>
              <a:endParaRPr kumimoji="1" lang="ja-JP" altLang="en-US" sz="1100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92D66DC3-B24B-1FB3-9A38-0DB20EC56429}"/>
                </a:ext>
              </a:extLst>
            </p:cNvPr>
            <p:cNvSpPr txBox="1"/>
            <p:nvPr/>
          </p:nvSpPr>
          <p:spPr>
            <a:xfrm>
              <a:off x="4031686" y="6470621"/>
              <a:ext cx="320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As</a:t>
              </a:r>
              <a:endParaRPr kumimoji="1" lang="ja-JP" altLang="en-US" sz="1100" dirty="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0D0FE1E3-832A-9F52-44EE-7CD4787EEF1C}"/>
                </a:ext>
              </a:extLst>
            </p:cNvPr>
            <p:cNvSpPr/>
            <p:nvPr/>
          </p:nvSpPr>
          <p:spPr>
            <a:xfrm>
              <a:off x="3857397" y="6295996"/>
              <a:ext cx="844550" cy="44527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DF1BCF25-B6ED-A2BD-F0C8-13B20B44EA37}"/>
              </a:ext>
            </a:extLst>
          </p:cNvPr>
          <p:cNvGrpSpPr/>
          <p:nvPr/>
        </p:nvGrpSpPr>
        <p:grpSpPr>
          <a:xfrm>
            <a:off x="782102" y="1734412"/>
            <a:ext cx="844550" cy="445274"/>
            <a:chOff x="3857397" y="6295996"/>
            <a:chExt cx="844550" cy="445274"/>
          </a:xfrm>
        </p:grpSpPr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14731EE4-40D7-ED4E-A6D6-75522A363BC1}"/>
                </a:ext>
              </a:extLst>
            </p:cNvPr>
            <p:cNvSpPr/>
            <p:nvPr/>
          </p:nvSpPr>
          <p:spPr>
            <a:xfrm>
              <a:off x="3933597" y="6563084"/>
              <a:ext cx="146050" cy="857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3E4B88D0-C521-5A3F-B7E5-77C073B308C3}"/>
                </a:ext>
              </a:extLst>
            </p:cNvPr>
            <p:cNvSpPr/>
            <p:nvPr/>
          </p:nvSpPr>
          <p:spPr>
            <a:xfrm>
              <a:off x="3933597" y="6388459"/>
              <a:ext cx="146050" cy="8572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C670B24A-5687-707D-6772-62B286046716}"/>
                </a:ext>
              </a:extLst>
            </p:cNvPr>
            <p:cNvSpPr txBox="1"/>
            <p:nvPr/>
          </p:nvSpPr>
          <p:spPr>
            <a:xfrm>
              <a:off x="4031686" y="6302346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Control</a:t>
              </a:r>
              <a:endParaRPr kumimoji="1" lang="ja-JP" altLang="en-US" sz="1100" dirty="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CCAB1DC8-8569-CE3C-3AE9-B7BC45705748}"/>
                </a:ext>
              </a:extLst>
            </p:cNvPr>
            <p:cNvSpPr txBox="1"/>
            <p:nvPr/>
          </p:nvSpPr>
          <p:spPr>
            <a:xfrm>
              <a:off x="4031686" y="6470621"/>
              <a:ext cx="320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As</a:t>
              </a:r>
              <a:endParaRPr kumimoji="1" lang="ja-JP" altLang="en-US" sz="1100" dirty="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431D9ACF-8467-488D-0DB3-BA70E73E40AE}"/>
                </a:ext>
              </a:extLst>
            </p:cNvPr>
            <p:cNvSpPr/>
            <p:nvPr/>
          </p:nvSpPr>
          <p:spPr>
            <a:xfrm>
              <a:off x="3857397" y="6295996"/>
              <a:ext cx="844550" cy="44527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048C9744-D78A-F0ED-1EDA-69187A603B57}"/>
              </a:ext>
            </a:extLst>
          </p:cNvPr>
          <p:cNvGrpSpPr/>
          <p:nvPr/>
        </p:nvGrpSpPr>
        <p:grpSpPr>
          <a:xfrm>
            <a:off x="2550877" y="1130983"/>
            <a:ext cx="387199" cy="246221"/>
            <a:chOff x="2288904" y="931957"/>
            <a:chExt cx="387199" cy="246221"/>
          </a:xfrm>
        </p:grpSpPr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232E157A-E961-81CD-AED9-6D53741FB376}"/>
                </a:ext>
              </a:extLst>
            </p:cNvPr>
            <p:cNvCxnSpPr>
              <a:cxnSpLocks/>
            </p:cNvCxnSpPr>
            <p:nvPr/>
          </p:nvCxnSpPr>
          <p:spPr>
            <a:xfrm>
              <a:off x="2288904" y="1121955"/>
              <a:ext cx="38719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C48D58ED-8537-3126-E7C0-8D19125D19F8}"/>
                </a:ext>
              </a:extLst>
            </p:cNvPr>
            <p:cNvSpPr txBox="1"/>
            <p:nvPr/>
          </p:nvSpPr>
          <p:spPr>
            <a:xfrm>
              <a:off x="2319116" y="931957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**</a:t>
              </a:r>
              <a:endParaRPr kumimoji="1" lang="ja-JP" altLang="en-US" sz="1000" dirty="0"/>
            </a:p>
          </p:txBody>
        </p:sp>
      </p:grp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01001E32-0543-17FA-989F-EE7EA665367F}"/>
              </a:ext>
            </a:extLst>
          </p:cNvPr>
          <p:cNvGrpSpPr/>
          <p:nvPr/>
        </p:nvGrpSpPr>
        <p:grpSpPr>
          <a:xfrm>
            <a:off x="5712596" y="1153648"/>
            <a:ext cx="312906" cy="246221"/>
            <a:chOff x="2868186" y="4920524"/>
            <a:chExt cx="312906" cy="246221"/>
          </a:xfrm>
        </p:grpSpPr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D4B30B0C-2A57-F000-7272-C4CE820BB824}"/>
                </a:ext>
              </a:extLst>
            </p:cNvPr>
            <p:cNvCxnSpPr>
              <a:cxnSpLocks/>
            </p:cNvCxnSpPr>
            <p:nvPr/>
          </p:nvCxnSpPr>
          <p:spPr>
            <a:xfrm>
              <a:off x="2964175" y="5081176"/>
              <a:ext cx="1300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A9DE1843-2F90-9B8C-78E9-CE84978FDD06}"/>
                </a:ext>
              </a:extLst>
            </p:cNvPr>
            <p:cNvSpPr txBox="1"/>
            <p:nvPr/>
          </p:nvSpPr>
          <p:spPr>
            <a:xfrm>
              <a:off x="2868186" y="4920524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**</a:t>
              </a:r>
              <a:endParaRPr kumimoji="1" lang="ja-JP" altLang="en-US" sz="1000" dirty="0"/>
            </a:p>
          </p:txBody>
        </p:sp>
      </p:grp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6DAED764-68D6-CC01-E9CF-7A52C4CDA573}"/>
              </a:ext>
            </a:extLst>
          </p:cNvPr>
          <p:cNvGrpSpPr/>
          <p:nvPr/>
        </p:nvGrpSpPr>
        <p:grpSpPr>
          <a:xfrm>
            <a:off x="5540789" y="1153648"/>
            <a:ext cx="312906" cy="246221"/>
            <a:chOff x="2868186" y="4920524"/>
            <a:chExt cx="312906" cy="246221"/>
          </a:xfrm>
        </p:grpSpPr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2BECA0A1-57B0-2B67-6834-851E64B052FC}"/>
                </a:ext>
              </a:extLst>
            </p:cNvPr>
            <p:cNvCxnSpPr>
              <a:cxnSpLocks/>
            </p:cNvCxnSpPr>
            <p:nvPr/>
          </p:nvCxnSpPr>
          <p:spPr>
            <a:xfrm>
              <a:off x="2964175" y="5081176"/>
              <a:ext cx="1300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E51EA1FC-EAC9-AFCA-601E-9D051786AFF9}"/>
                </a:ext>
              </a:extLst>
            </p:cNvPr>
            <p:cNvSpPr txBox="1"/>
            <p:nvPr/>
          </p:nvSpPr>
          <p:spPr>
            <a:xfrm>
              <a:off x="2868186" y="4920524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**</a:t>
              </a:r>
              <a:endParaRPr kumimoji="1" lang="ja-JP" altLang="en-US" sz="1000" dirty="0"/>
            </a:p>
          </p:txBody>
        </p: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660A9648-AA7E-E7A3-B04C-98B6CF282F72}"/>
              </a:ext>
            </a:extLst>
          </p:cNvPr>
          <p:cNvGrpSpPr/>
          <p:nvPr/>
        </p:nvGrpSpPr>
        <p:grpSpPr>
          <a:xfrm>
            <a:off x="5368982" y="1153648"/>
            <a:ext cx="312906" cy="246221"/>
            <a:chOff x="2868186" y="4920524"/>
            <a:chExt cx="312906" cy="246221"/>
          </a:xfrm>
        </p:grpSpPr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0BDADC40-A390-A17D-5C32-B56C77C04D7F}"/>
                </a:ext>
              </a:extLst>
            </p:cNvPr>
            <p:cNvCxnSpPr>
              <a:cxnSpLocks/>
            </p:cNvCxnSpPr>
            <p:nvPr/>
          </p:nvCxnSpPr>
          <p:spPr>
            <a:xfrm>
              <a:off x="2964175" y="5081176"/>
              <a:ext cx="1300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613355B7-1532-684F-0739-2BA46225F58F}"/>
                </a:ext>
              </a:extLst>
            </p:cNvPr>
            <p:cNvSpPr txBox="1"/>
            <p:nvPr/>
          </p:nvSpPr>
          <p:spPr>
            <a:xfrm>
              <a:off x="2868186" y="4920524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**</a:t>
              </a:r>
              <a:endParaRPr kumimoji="1" lang="ja-JP" altLang="en-US" sz="1000" dirty="0"/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F6AA117B-BA50-5543-9FDB-FC74C1C8A785}"/>
              </a:ext>
            </a:extLst>
          </p:cNvPr>
          <p:cNvGrpSpPr/>
          <p:nvPr/>
        </p:nvGrpSpPr>
        <p:grpSpPr>
          <a:xfrm>
            <a:off x="5194159" y="1153648"/>
            <a:ext cx="312906" cy="246221"/>
            <a:chOff x="2868186" y="4920524"/>
            <a:chExt cx="312906" cy="246221"/>
          </a:xfrm>
        </p:grpSpPr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443BA038-94F9-6A07-EF05-AF37C39913E1}"/>
                </a:ext>
              </a:extLst>
            </p:cNvPr>
            <p:cNvCxnSpPr>
              <a:cxnSpLocks/>
            </p:cNvCxnSpPr>
            <p:nvPr/>
          </p:nvCxnSpPr>
          <p:spPr>
            <a:xfrm>
              <a:off x="2964175" y="5081176"/>
              <a:ext cx="1300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A262F451-4035-6730-EBA4-8F1011932B06}"/>
                </a:ext>
              </a:extLst>
            </p:cNvPr>
            <p:cNvSpPr txBox="1"/>
            <p:nvPr/>
          </p:nvSpPr>
          <p:spPr>
            <a:xfrm>
              <a:off x="2868186" y="4920524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**</a:t>
              </a:r>
              <a:endParaRPr kumimoji="1" lang="ja-JP" altLang="en-US" sz="1000" dirty="0"/>
            </a:p>
          </p:txBody>
        </p:sp>
      </p:grp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121ACE5-D7A4-9208-11F6-308B672CC2EA}"/>
              </a:ext>
            </a:extLst>
          </p:cNvPr>
          <p:cNvSpPr txBox="1"/>
          <p:nvPr/>
        </p:nvSpPr>
        <p:spPr>
          <a:xfrm>
            <a:off x="2972447" y="385099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/>
              <a:t>chr_all</a:t>
            </a:r>
            <a:endParaRPr kumimoji="1" lang="ja-JP" altLang="en-US" sz="800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8898C5B-F9D4-1D4A-DF3B-E4762278C219}"/>
              </a:ext>
            </a:extLst>
          </p:cNvPr>
          <p:cNvSpPr txBox="1"/>
          <p:nvPr/>
        </p:nvSpPr>
        <p:spPr>
          <a:xfrm>
            <a:off x="2972447" y="1693593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/>
              <a:t>chr_all</a:t>
            </a:r>
            <a:endParaRPr kumimoji="1" lang="ja-JP" altLang="en-US" sz="800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FF2D1E9D-DCF3-3FA5-86A6-89C8CB34B95F}"/>
              </a:ext>
            </a:extLst>
          </p:cNvPr>
          <p:cNvSpPr txBox="1"/>
          <p:nvPr/>
        </p:nvSpPr>
        <p:spPr>
          <a:xfrm>
            <a:off x="673788" y="5364507"/>
            <a:ext cx="5489945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/>
              <a:t>Fig. S2. Violin plots of DNA methylation levels.</a:t>
            </a:r>
          </a:p>
          <a:p>
            <a:r>
              <a:rPr lang="en-US" altLang="ja-JP" sz="1100" dirty="0"/>
              <a:t>Violin plots of all </a:t>
            </a:r>
            <a:r>
              <a:rPr lang="en-US" altLang="ja-JP" sz="1100" dirty="0" err="1"/>
              <a:t>CpGs</a:t>
            </a:r>
            <a:r>
              <a:rPr lang="en-US" altLang="ja-JP" sz="1100" dirty="0"/>
              <a:t> and annotated genomic regions in </a:t>
            </a:r>
            <a:r>
              <a:rPr lang="en-US" altLang="ja-JP" sz="1100" dirty="0" err="1"/>
              <a:t>prospermatogonia</a:t>
            </a:r>
            <a:r>
              <a:rPr lang="en-US" altLang="ja-JP" sz="1100" dirty="0"/>
              <a:t> (A, B) and type A spermatogonia (C, D). Red cross mark represents average methylation levels. The differences in the methylation levels between the control and arsenic group were tested by Welch’s t test</a:t>
            </a:r>
            <a:r>
              <a:rPr lang="ja-JP" altLang="en-US" sz="1100" dirty="0"/>
              <a:t> </a:t>
            </a:r>
            <a:r>
              <a:rPr lang="en-US" altLang="ja-JP" sz="1100" dirty="0"/>
              <a:t>**p &lt; 0.001.</a:t>
            </a: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48F8492-F2B1-633E-6715-4E1E5275AB94}"/>
              </a:ext>
            </a:extLst>
          </p:cNvPr>
          <p:cNvSpPr txBox="1"/>
          <p:nvPr/>
        </p:nvSpPr>
        <p:spPr>
          <a:xfrm>
            <a:off x="5935949" y="8693841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2</a:t>
            </a:r>
            <a:endParaRPr kumimoji="1" lang="ja-JP" altLang="en-US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60A8C6D5-9717-C25C-1C2F-7DBCC98C62E5}"/>
              </a:ext>
            </a:extLst>
          </p:cNvPr>
          <p:cNvSpPr txBox="1"/>
          <p:nvPr/>
        </p:nvSpPr>
        <p:spPr>
          <a:xfrm>
            <a:off x="681957" y="1280801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A)</a:t>
            </a:r>
            <a:endParaRPr kumimoji="1" lang="ja-JP" altLang="en-US" sz="12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96F0B9F-793D-AAEA-0AB8-D2F7CAFA9B69}"/>
              </a:ext>
            </a:extLst>
          </p:cNvPr>
          <p:cNvSpPr txBox="1"/>
          <p:nvPr/>
        </p:nvSpPr>
        <p:spPr>
          <a:xfrm>
            <a:off x="3440076" y="1280801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B)</a:t>
            </a:r>
            <a:endParaRPr kumimoji="1" lang="ja-JP" altLang="en-US" sz="12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A6E73817-E35B-740E-3CC6-971EE8926312}"/>
              </a:ext>
            </a:extLst>
          </p:cNvPr>
          <p:cNvSpPr txBox="1"/>
          <p:nvPr/>
        </p:nvSpPr>
        <p:spPr>
          <a:xfrm>
            <a:off x="681957" y="3375282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C)</a:t>
            </a:r>
            <a:endParaRPr kumimoji="1" lang="ja-JP" altLang="en-US" sz="12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08D43829-ED77-931F-DE11-CA458A279C5C}"/>
              </a:ext>
            </a:extLst>
          </p:cNvPr>
          <p:cNvSpPr txBox="1"/>
          <p:nvPr/>
        </p:nvSpPr>
        <p:spPr>
          <a:xfrm>
            <a:off x="3440076" y="3375282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D)</a:t>
            </a:r>
            <a:endParaRPr kumimoji="1" lang="ja-JP" altLang="en-US" sz="12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7D66790-0B64-ED4E-C874-D2CF15D0BC1C}"/>
              </a:ext>
            </a:extLst>
          </p:cNvPr>
          <p:cNvSpPr txBox="1"/>
          <p:nvPr/>
        </p:nvSpPr>
        <p:spPr>
          <a:xfrm>
            <a:off x="3890188" y="1127103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[%]</a:t>
            </a:r>
            <a:endParaRPr kumimoji="1" lang="ja-JP" altLang="en-US" sz="800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EE19885-9195-E0F9-CC9D-5798CDA98FD6}"/>
              </a:ext>
            </a:extLst>
          </p:cNvPr>
          <p:cNvSpPr txBox="1"/>
          <p:nvPr/>
        </p:nvSpPr>
        <p:spPr>
          <a:xfrm>
            <a:off x="1894299" y="1184425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[%]</a:t>
            </a:r>
            <a:endParaRPr kumimoji="1" lang="ja-JP" altLang="en-US" sz="8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1E23DC99-80EA-BCDF-05AD-AEBF8584F674}"/>
              </a:ext>
            </a:extLst>
          </p:cNvPr>
          <p:cNvSpPr txBox="1"/>
          <p:nvPr/>
        </p:nvSpPr>
        <p:spPr>
          <a:xfrm>
            <a:off x="1894299" y="3409350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[%]</a:t>
            </a:r>
            <a:endParaRPr kumimoji="1" lang="ja-JP" altLang="en-US" sz="800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F994DB30-C64C-F303-B441-C57C0B85299B}"/>
              </a:ext>
            </a:extLst>
          </p:cNvPr>
          <p:cNvSpPr txBox="1"/>
          <p:nvPr/>
        </p:nvSpPr>
        <p:spPr>
          <a:xfrm>
            <a:off x="3890618" y="3231877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[%]</a:t>
            </a:r>
            <a:endParaRPr kumimoji="1" lang="ja-JP" altLang="en-US" sz="800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F1569D30-CBA0-B7AF-BD26-1F1703B342D0}"/>
              </a:ext>
            </a:extLst>
          </p:cNvPr>
          <p:cNvSpPr/>
          <p:nvPr/>
        </p:nvSpPr>
        <p:spPr>
          <a:xfrm>
            <a:off x="2520615" y="2705060"/>
            <a:ext cx="447721" cy="1226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47FB439-0218-7179-D105-1F95A7F9A2DF}"/>
              </a:ext>
            </a:extLst>
          </p:cNvPr>
          <p:cNvSpPr txBox="1"/>
          <p:nvPr/>
        </p:nvSpPr>
        <p:spPr>
          <a:xfrm>
            <a:off x="2208604" y="2636392"/>
            <a:ext cx="10550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prospermatogonia</a:t>
            </a:r>
            <a:endParaRPr kumimoji="1" lang="ja-JP" altLang="en-US" sz="900" dirty="0"/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4A406BF7-B24A-AB00-3491-95BE2BDFC538}"/>
              </a:ext>
            </a:extLst>
          </p:cNvPr>
          <p:cNvSpPr/>
          <p:nvPr/>
        </p:nvSpPr>
        <p:spPr>
          <a:xfrm>
            <a:off x="2550091" y="4916245"/>
            <a:ext cx="447721" cy="1226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8D7495BA-0BC4-0841-C114-80F1EBAC0563}"/>
              </a:ext>
            </a:extLst>
          </p:cNvPr>
          <p:cNvSpPr txBox="1"/>
          <p:nvPr/>
        </p:nvSpPr>
        <p:spPr>
          <a:xfrm>
            <a:off x="2141095" y="4847577"/>
            <a:ext cx="12218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type A spermatogonia</a:t>
            </a:r>
            <a:endParaRPr kumimoji="1" lang="ja-JP" altLang="en-US" sz="900" dirty="0"/>
          </a:p>
        </p:txBody>
      </p:sp>
    </p:spTree>
    <p:extLst>
      <p:ext uri="{BB962C8B-B14F-4D97-AF65-F5344CB8AC3E}">
        <p14:creationId xmlns:p14="http://schemas.microsoft.com/office/powerpoint/2010/main" val="2536471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0</TotalTime>
  <Words>270</Words>
  <Application>Microsoft Office PowerPoint</Application>
  <PresentationFormat>画面に合わせる (4:3)</PresentationFormat>
  <Paragraphs>7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hiro SUZUKI</dc:creator>
  <cp:lastModifiedBy>Takehiro SUZUKI</cp:lastModifiedBy>
  <cp:revision>156</cp:revision>
  <cp:lastPrinted>2026-02-26T05:29:28Z</cp:lastPrinted>
  <dcterms:created xsi:type="dcterms:W3CDTF">2025-10-07T04:52:37Z</dcterms:created>
  <dcterms:modified xsi:type="dcterms:W3CDTF">2026-04-16T05:51:18Z</dcterms:modified>
</cp:coreProperties>
</file>